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609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567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1769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885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868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48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89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319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488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925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545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2B1DA-ADC8-4A8D-8C47-45982E8A9629}" type="datetimeFigureOut">
              <a:rPr lang="en-US" smtClean="0"/>
              <a:t>12-Feb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ED2D5-499A-4B8B-B900-8A48C4451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37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8676" y="136634"/>
            <a:ext cx="11918732" cy="661659"/>
          </a:xfrm>
        </p:spPr>
        <p:txBody>
          <a:bodyPr>
            <a:normAutofit/>
          </a:bodyPr>
          <a:lstStyle/>
          <a:p>
            <a:r>
              <a:rPr lang="en-US" sz="2000" dirty="0" smtClean="0"/>
              <a:t>Figure </a:t>
            </a:r>
            <a:r>
              <a:rPr lang="en-US" sz="2000" dirty="0" smtClean="0"/>
              <a:t>S1. The DNA sequencing result of </a:t>
            </a:r>
            <a:r>
              <a:rPr lang="en-US" sz="2000" i="1" dirty="0" smtClean="0"/>
              <a:t>StAPI5</a:t>
            </a:r>
            <a:r>
              <a:rPr lang="en-US" sz="2000" dirty="0" smtClean="0"/>
              <a:t> gene in the expression vector pRI201-AN using vector-specific primer M13 forward by </a:t>
            </a:r>
            <a:r>
              <a:rPr lang="en-US" sz="2000" dirty="0" err="1" smtClean="0"/>
              <a:t>Macrogen</a:t>
            </a:r>
            <a:r>
              <a:rPr lang="en-US" sz="2000" dirty="0" smtClean="0"/>
              <a:t> company using the Sanger technique</a:t>
            </a:r>
            <a:endParaRPr lang="en-US" sz="20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6283" y="977462"/>
            <a:ext cx="9703517" cy="5880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61581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3794" y="0"/>
            <a:ext cx="970351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7520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7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Figure S1. The DNA sequencing result of StAPI5 gene in the expression vector pRI201-AN using vector-specific primer M13 forward by Macrogen company using the Sanger techniqu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. S1. The DNA sequencing result of StAPI5 gene in the expression vector pRI201-AN using vector-specific primer M13 forward by Macrogen company using the Sanger technique</dc:title>
  <dc:creator>masoud gerivani</dc:creator>
  <cp:lastModifiedBy>zhila osmani</cp:lastModifiedBy>
  <cp:revision>6</cp:revision>
  <dcterms:created xsi:type="dcterms:W3CDTF">2021-11-09T22:02:06Z</dcterms:created>
  <dcterms:modified xsi:type="dcterms:W3CDTF">2022-02-12T08:35:09Z</dcterms:modified>
</cp:coreProperties>
</file>